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34" autoAdjust="0"/>
    <p:restoredTop sz="93073" autoAdjust="0"/>
  </p:normalViewPr>
  <p:slideViewPr>
    <p:cSldViewPr snapToObjects="1">
      <p:cViewPr>
        <p:scale>
          <a:sx n="110" d="100"/>
          <a:sy n="110" d="100"/>
        </p:scale>
        <p:origin x="-2562" y="-36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53F8B-DB27-C04B-88F9-15FEAE48203D}" type="datetimeFigureOut">
              <a:rPr lang="en-US" smtClean="0"/>
              <a:t>6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541EB-B334-1746-81D7-6880FF750B9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53F8B-DB27-C04B-88F9-15FEAE48203D}" type="datetimeFigureOut">
              <a:rPr lang="en-US" smtClean="0"/>
              <a:t>6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541EB-B334-1746-81D7-6880FF750B9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53F8B-DB27-C04B-88F9-15FEAE48203D}" type="datetimeFigureOut">
              <a:rPr lang="en-US" smtClean="0"/>
              <a:t>6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541EB-B334-1746-81D7-6880FF750B9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53F8B-DB27-C04B-88F9-15FEAE48203D}" type="datetimeFigureOut">
              <a:rPr lang="en-US" smtClean="0"/>
              <a:t>6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541EB-B334-1746-81D7-6880FF750B9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53F8B-DB27-C04B-88F9-15FEAE48203D}" type="datetimeFigureOut">
              <a:rPr lang="en-US" smtClean="0"/>
              <a:t>6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541EB-B334-1746-81D7-6880FF750B9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53F8B-DB27-C04B-88F9-15FEAE48203D}" type="datetimeFigureOut">
              <a:rPr lang="en-US" smtClean="0"/>
              <a:t>6/2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541EB-B334-1746-81D7-6880FF750B9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53F8B-DB27-C04B-88F9-15FEAE48203D}" type="datetimeFigureOut">
              <a:rPr lang="en-US" smtClean="0"/>
              <a:t>6/2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541EB-B334-1746-81D7-6880FF750B9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53F8B-DB27-C04B-88F9-15FEAE48203D}" type="datetimeFigureOut">
              <a:rPr lang="en-US" smtClean="0"/>
              <a:t>6/2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541EB-B334-1746-81D7-6880FF750B9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53F8B-DB27-C04B-88F9-15FEAE48203D}" type="datetimeFigureOut">
              <a:rPr lang="en-US" smtClean="0"/>
              <a:t>6/2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541EB-B334-1746-81D7-6880FF750B9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53F8B-DB27-C04B-88F9-15FEAE48203D}" type="datetimeFigureOut">
              <a:rPr lang="en-US" smtClean="0"/>
              <a:t>6/2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541EB-B334-1746-81D7-6880FF750B9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53F8B-DB27-C04B-88F9-15FEAE48203D}" type="datetimeFigureOut">
              <a:rPr lang="en-US" smtClean="0"/>
              <a:t>6/2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541EB-B334-1746-81D7-6880FF750B9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953F8B-DB27-C04B-88F9-15FEAE48203D}" type="datetimeFigureOut">
              <a:rPr lang="en-US" smtClean="0"/>
              <a:t>6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7541EB-B334-1746-81D7-6880FF750B93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2956" y="1447799"/>
            <a:ext cx="1244176" cy="2358579"/>
          </a:xfrm>
          <a:prstGeom prst="rect">
            <a:avLst/>
          </a:prstGeom>
        </p:spPr>
      </p:pic>
      <p:sp>
        <p:nvSpPr>
          <p:cNvPr id="10" name="Rectangle 9"/>
          <p:cNvSpPr/>
          <p:nvPr/>
        </p:nvSpPr>
        <p:spPr>
          <a:xfrm>
            <a:off x="4055544" y="250391"/>
            <a:ext cx="609600" cy="3048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</a:rPr>
              <a:t>B</a:t>
            </a:r>
          </a:p>
        </p:txBody>
      </p:sp>
      <p:sp>
        <p:nvSpPr>
          <p:cNvPr id="11" name="Rectangle 10"/>
          <p:cNvSpPr/>
          <p:nvPr/>
        </p:nvSpPr>
        <p:spPr>
          <a:xfrm>
            <a:off x="533400" y="240289"/>
            <a:ext cx="609600" cy="3048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 smtClean="0">
                <a:solidFill>
                  <a:schemeClr val="tx1"/>
                </a:solidFill>
              </a:rPr>
              <a:t>A</a:t>
            </a:r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4055544" y="3651848"/>
            <a:ext cx="609600" cy="3048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</a:rPr>
              <a:t>C</a:t>
            </a:r>
          </a:p>
        </p:txBody>
      </p:sp>
      <p:sp>
        <p:nvSpPr>
          <p:cNvPr id="13" name="Rectangle 12"/>
          <p:cNvSpPr/>
          <p:nvPr/>
        </p:nvSpPr>
        <p:spPr>
          <a:xfrm>
            <a:off x="1295400" y="97102"/>
            <a:ext cx="1447800" cy="135069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r>
              <a:rPr lang="en-US" sz="10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igh resolution ladder</a:t>
            </a:r>
          </a:p>
          <a:p>
            <a:r>
              <a:rPr lang="en-US" sz="10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</a:p>
          <a:p>
            <a:endParaRPr lang="en-US" sz="10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0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ustom ladder</a:t>
            </a:r>
          </a:p>
          <a:p>
            <a:endParaRPr lang="en-US" sz="1000" b="1" dirty="0" smtClean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1000" b="1" dirty="0" smtClean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0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NA Sample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4800600" y="6019800"/>
            <a:ext cx="20574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rmalized Position Along Transcript (5’ to 3’)</a:t>
            </a:r>
            <a:endParaRPr lang="en-US" sz="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 rot="16200000">
            <a:off x="3788844" y="4898767"/>
            <a:ext cx="11430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verage (Normalized)</a:t>
            </a:r>
            <a:endParaRPr lang="en-US" sz="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734839" y="2114550"/>
            <a:ext cx="68646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00 </a:t>
            </a:r>
            <a:r>
              <a:rPr lang="en-US" sz="7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endParaRPr 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734839" y="2417837"/>
            <a:ext cx="68646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sz="7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0 </a:t>
            </a:r>
            <a:r>
              <a:rPr lang="en-US" sz="7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endParaRPr 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734839" y="2653528"/>
            <a:ext cx="68646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7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0 </a:t>
            </a:r>
            <a:r>
              <a:rPr lang="en-US" sz="7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endParaRPr 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759694" y="3143250"/>
            <a:ext cx="68646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60 </a:t>
            </a:r>
            <a:r>
              <a:rPr lang="en-US" sz="7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endParaRPr 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759694" y="3302057"/>
            <a:ext cx="68646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40 </a:t>
            </a:r>
            <a:r>
              <a:rPr lang="en-US" sz="7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endParaRPr 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743200" y="3311553"/>
            <a:ext cx="68646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croRNA</a:t>
            </a:r>
            <a:endParaRPr 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295400" y="4003470"/>
            <a:ext cx="68646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4</a:t>
            </a:r>
            <a:r>
              <a:rPr 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US" sz="7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7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endParaRPr 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2045044" y="4024877"/>
            <a:ext cx="68646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60 </a:t>
            </a:r>
            <a:r>
              <a:rPr lang="en-US" sz="7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endParaRPr lang="en-US" sz="7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6" name="Straight Arrow Connector 25"/>
          <p:cNvCxnSpPr/>
          <p:nvPr/>
        </p:nvCxnSpPr>
        <p:spPr>
          <a:xfrm flipH="1">
            <a:off x="2590800" y="3411580"/>
            <a:ext cx="304800" cy="0"/>
          </a:xfrm>
          <a:prstGeom prst="straightConnector1">
            <a:avLst/>
          </a:prstGeom>
          <a:ln>
            <a:solidFill>
              <a:srgbClr val="FFFF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/>
          <p:cNvCxnSpPr/>
          <p:nvPr/>
        </p:nvCxnSpPr>
        <p:spPr>
          <a:xfrm flipH="1" flipV="1">
            <a:off x="2209800" y="3311553"/>
            <a:ext cx="228600" cy="714806"/>
          </a:xfrm>
          <a:prstGeom prst="straightConnector1">
            <a:avLst/>
          </a:prstGeom>
          <a:ln>
            <a:solidFill>
              <a:srgbClr val="FFFF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/>
          <p:cNvCxnSpPr/>
          <p:nvPr/>
        </p:nvCxnSpPr>
        <p:spPr>
          <a:xfrm flipV="1">
            <a:off x="1752600" y="3411580"/>
            <a:ext cx="266700" cy="591890"/>
          </a:xfrm>
          <a:prstGeom prst="straightConnector1">
            <a:avLst/>
          </a:prstGeom>
          <a:ln>
            <a:solidFill>
              <a:srgbClr val="FFFF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4693920" y="5804141"/>
            <a:ext cx="322532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        10       20       30         40        50       60        70        80        90      100</a:t>
            </a:r>
            <a:endParaRPr 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 rot="16200000">
            <a:off x="3466404" y="4680110"/>
            <a:ext cx="239747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0     2      4      6      8     10    12   14    16   18</a:t>
            </a:r>
            <a:endParaRPr 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66310" y="4103497"/>
            <a:ext cx="2889265" cy="1700644"/>
          </a:xfrm>
          <a:prstGeom prst="rect">
            <a:avLst/>
          </a:prstGeom>
        </p:spPr>
      </p:pic>
      <p:sp>
        <p:nvSpPr>
          <p:cNvPr id="29" name="TextBox 28"/>
          <p:cNvSpPr txBox="1"/>
          <p:nvPr/>
        </p:nvSpPr>
        <p:spPr>
          <a:xfrm>
            <a:off x="5105400" y="3952838"/>
            <a:ext cx="20574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NSCRIPT COVERAGE</a:t>
            </a:r>
            <a:endParaRPr 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4565116" y="2469358"/>
            <a:ext cx="335198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35      100  150 200        300       400    500 600     1000  2000        10380                               (</a:t>
            </a:r>
            <a:r>
              <a:rPr lang="en-US" sz="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sz="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79499" y="772450"/>
            <a:ext cx="3383001" cy="16884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703611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75</TotalTime>
  <Words>79</Words>
  <Application>Microsoft Office PowerPoint</Application>
  <PresentationFormat>On-screen Show (4:3)</PresentationFormat>
  <Paragraphs>2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NMRC-Frederick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ohit Patel</dc:creator>
  <cp:lastModifiedBy>Cer, Regina CTR NMRC</cp:lastModifiedBy>
  <cp:revision>30</cp:revision>
  <dcterms:created xsi:type="dcterms:W3CDTF">2017-06-01T18:27:02Z</dcterms:created>
  <dcterms:modified xsi:type="dcterms:W3CDTF">2017-06-20T16:39:43Z</dcterms:modified>
</cp:coreProperties>
</file>